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17279938" cy="11520488"/>
  <p:notesSz cx="6858000" cy="9144000"/>
  <p:defaultTextStyle>
    <a:defPPr>
      <a:defRPr lang="ko-KR"/>
    </a:defPPr>
    <a:lvl1pPr marL="0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365730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731462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097192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1462923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1828654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2194385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2560115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2925846" algn="l" defTabSz="731462" rtl="0" eaLnBrk="1" latinLnBrk="1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53" d="100"/>
          <a:sy n="53" d="100"/>
        </p:scale>
        <p:origin x="104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3&#45380;\penicilllium\RNA%20seq\from%20DNA%20link\20140919_analysys_results\&#48516;&#49437;&#44208;&#44284;_results\2.Functional_Annotation\IPR-1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3200" b="1" i="0" u="sng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/defense-related </a:t>
            </a:r>
            <a:r>
              <a:rPr lang="en-US" altLang="ko-KR" sz="3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</c:rich>
      </c:tx>
      <c:layout>
        <c:manualLayout>
          <c:xMode val="edge"/>
          <c:yMode val="edge"/>
          <c:x val="0.3105407558320944"/>
          <c:y val="2.19478737997256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200" b="1" i="0" u="sng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45998685828607083"/>
          <c:y val="0.19658870999334038"/>
          <c:w val="0.51514842237690006"/>
          <c:h val="0.59917468649752115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5!$A$1</c:f>
              <c:strCache>
                <c:ptCount val="1"/>
                <c:pt idx="0">
                  <c:v>ROS/defese-related gen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5!$D$3:$D$10</c:f>
              <c:strCache>
                <c:ptCount val="8"/>
                <c:pt idx="0">
                  <c:v>Dyp-type peroxidase (446037)</c:v>
                </c:pt>
                <c:pt idx="1">
                  <c:v>Chloroperoxidase (332379)</c:v>
                </c:pt>
                <c:pt idx="2">
                  <c:v>Chloroperoxidase (443906)</c:v>
                </c:pt>
                <c:pt idx="3">
                  <c:v>Glutathione S-transferase, C-terminal (344745)</c:v>
                </c:pt>
                <c:pt idx="4">
                  <c:v>Glutathione S-transferase, C-terminal-like (372157)</c:v>
                </c:pt>
                <c:pt idx="5">
                  <c:v>Glutathione S-transferase, C-terminal-like (439045)</c:v>
                </c:pt>
                <c:pt idx="6">
                  <c:v>Manganese and iron superoxide dismutase (372225)</c:v>
                </c:pt>
                <c:pt idx="7">
                  <c:v>Catalase (324436)</c:v>
                </c:pt>
              </c:strCache>
            </c:strRef>
          </c:cat>
          <c:val>
            <c:numRef>
              <c:f>Sheet5!$E$3:$E$10</c:f>
              <c:numCache>
                <c:formatCode>General</c:formatCode>
                <c:ptCount val="8"/>
                <c:pt idx="0">
                  <c:v>4.6523700000000003</c:v>
                </c:pt>
                <c:pt idx="1">
                  <c:v>2.52536</c:v>
                </c:pt>
                <c:pt idx="2">
                  <c:v>5.01722</c:v>
                </c:pt>
                <c:pt idx="3">
                  <c:v>-3.7739099999999999</c:v>
                </c:pt>
                <c:pt idx="4">
                  <c:v>-5.2370700000000001</c:v>
                </c:pt>
                <c:pt idx="5">
                  <c:v>-2.23502</c:v>
                </c:pt>
                <c:pt idx="6">
                  <c:v>-3.8683800000000002</c:v>
                </c:pt>
                <c:pt idx="7">
                  <c:v>-4.132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12446632"/>
        <c:axId val="312447808"/>
      </c:barChart>
      <c:catAx>
        <c:axId val="3124466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0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r Description (#proteinId)</a:t>
                </a:r>
                <a:endParaRPr lang="ko-KR" sz="20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7532954128837593E-3"/>
              <c:y val="0.195878111383584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12447808"/>
        <c:crosses val="autoZero"/>
        <c:auto val="1"/>
        <c:lblAlgn val="ctr"/>
        <c:lblOffset val="100"/>
        <c:noMultiLvlLbl val="0"/>
      </c:catAx>
      <c:valAx>
        <c:axId val="312447808"/>
        <c:scaling>
          <c:orientation val="minMax"/>
          <c:max val="8"/>
          <c:min val="-8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8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g2 (SSF/SmF)</a:t>
                </a:r>
                <a:endParaRPr lang="ko-KR" sz="18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63953776407319696"/>
              <c:y val="0.916172083427843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12446632"/>
        <c:crosses val="autoZero"/>
        <c:crossBetween val="between"/>
        <c:majorUnit val="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+mn-ea"/>
          <a:ea typeface="+mn-ea"/>
          <a:cs typeface="Arial Unicode MS" panose="020B0604020202020204" pitchFamily="50" charset="-127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95996" y="1885414"/>
            <a:ext cx="14687947" cy="4010837"/>
          </a:xfrm>
        </p:spPr>
        <p:txBody>
          <a:bodyPr anchor="b"/>
          <a:lstStyle>
            <a:lvl1pPr algn="ctr">
              <a:defRPr sz="1007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59992" y="6050924"/>
            <a:ext cx="12959954" cy="2781450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050" indent="0" algn="ctr">
              <a:buNone/>
              <a:defRPr sz="3360"/>
            </a:lvl2pPr>
            <a:lvl3pPr marL="1536101" indent="0" algn="ctr">
              <a:buNone/>
              <a:defRPr sz="3024"/>
            </a:lvl3pPr>
            <a:lvl4pPr marL="2304151" indent="0" algn="ctr">
              <a:buNone/>
              <a:defRPr sz="2688"/>
            </a:lvl4pPr>
            <a:lvl5pPr marL="3072201" indent="0" algn="ctr">
              <a:buNone/>
              <a:defRPr sz="2688"/>
            </a:lvl5pPr>
            <a:lvl6pPr marL="3840251" indent="0" algn="ctr">
              <a:buNone/>
              <a:defRPr sz="2688"/>
            </a:lvl6pPr>
            <a:lvl7pPr marL="4608302" indent="0" algn="ctr">
              <a:buNone/>
              <a:defRPr sz="2688"/>
            </a:lvl7pPr>
            <a:lvl8pPr marL="5376352" indent="0" algn="ctr">
              <a:buNone/>
              <a:defRPr sz="2688"/>
            </a:lvl8pPr>
            <a:lvl9pPr marL="6144402" indent="0" algn="ctr">
              <a:buNone/>
              <a:defRPr sz="2688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708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7349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365956" y="613359"/>
            <a:ext cx="3725987" cy="976308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87997" y="613359"/>
            <a:ext cx="10961961" cy="976308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333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9126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8996" y="2872125"/>
            <a:ext cx="14903947" cy="4792202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8996" y="7709663"/>
            <a:ext cx="14903947" cy="2520106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05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101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15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20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251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30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35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440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5085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87996" y="3066796"/>
            <a:ext cx="7343974" cy="73096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47968" y="3066796"/>
            <a:ext cx="7343974" cy="73096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1309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613362"/>
            <a:ext cx="14903947" cy="22267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90248" y="2824120"/>
            <a:ext cx="7310223" cy="138405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050" indent="0">
              <a:buNone/>
              <a:defRPr sz="3360" b="1"/>
            </a:lvl2pPr>
            <a:lvl3pPr marL="1536101" indent="0">
              <a:buNone/>
              <a:defRPr sz="3024" b="1"/>
            </a:lvl3pPr>
            <a:lvl4pPr marL="2304151" indent="0">
              <a:buNone/>
              <a:defRPr sz="2688" b="1"/>
            </a:lvl4pPr>
            <a:lvl5pPr marL="3072201" indent="0">
              <a:buNone/>
              <a:defRPr sz="2688" b="1"/>
            </a:lvl5pPr>
            <a:lvl6pPr marL="3840251" indent="0">
              <a:buNone/>
              <a:defRPr sz="2688" b="1"/>
            </a:lvl6pPr>
            <a:lvl7pPr marL="4608302" indent="0">
              <a:buNone/>
              <a:defRPr sz="2688" b="1"/>
            </a:lvl7pPr>
            <a:lvl8pPr marL="5376352" indent="0">
              <a:buNone/>
              <a:defRPr sz="2688" b="1"/>
            </a:lvl8pPr>
            <a:lvl9pPr marL="6144402" indent="0">
              <a:buNone/>
              <a:defRPr sz="26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90248" y="4208178"/>
            <a:ext cx="7310223" cy="6189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747970" y="2824120"/>
            <a:ext cx="7346224" cy="138405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050" indent="0">
              <a:buNone/>
              <a:defRPr sz="3360" b="1"/>
            </a:lvl2pPr>
            <a:lvl3pPr marL="1536101" indent="0">
              <a:buNone/>
              <a:defRPr sz="3024" b="1"/>
            </a:lvl3pPr>
            <a:lvl4pPr marL="2304151" indent="0">
              <a:buNone/>
              <a:defRPr sz="2688" b="1"/>
            </a:lvl4pPr>
            <a:lvl5pPr marL="3072201" indent="0">
              <a:buNone/>
              <a:defRPr sz="2688" b="1"/>
            </a:lvl5pPr>
            <a:lvl6pPr marL="3840251" indent="0">
              <a:buNone/>
              <a:defRPr sz="2688" b="1"/>
            </a:lvl6pPr>
            <a:lvl7pPr marL="4608302" indent="0">
              <a:buNone/>
              <a:defRPr sz="2688" b="1"/>
            </a:lvl7pPr>
            <a:lvl8pPr marL="5376352" indent="0">
              <a:buNone/>
              <a:defRPr sz="2688" b="1"/>
            </a:lvl8pPr>
            <a:lvl9pPr marL="6144402" indent="0">
              <a:buNone/>
              <a:defRPr sz="26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747970" y="4208178"/>
            <a:ext cx="7346224" cy="6189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7023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5399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162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768032"/>
            <a:ext cx="5573230" cy="268811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346224" y="1658740"/>
            <a:ext cx="8747969" cy="8187013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6" y="3456146"/>
            <a:ext cx="5573230" cy="6402939"/>
          </a:xfrm>
        </p:spPr>
        <p:txBody>
          <a:bodyPr/>
          <a:lstStyle>
            <a:lvl1pPr marL="0" indent="0">
              <a:buNone/>
              <a:defRPr sz="2688"/>
            </a:lvl1pPr>
            <a:lvl2pPr marL="768050" indent="0">
              <a:buNone/>
              <a:defRPr sz="2352"/>
            </a:lvl2pPr>
            <a:lvl3pPr marL="1536101" indent="0">
              <a:buNone/>
              <a:defRPr sz="2016"/>
            </a:lvl3pPr>
            <a:lvl4pPr marL="2304151" indent="0">
              <a:buNone/>
              <a:defRPr sz="1680"/>
            </a:lvl4pPr>
            <a:lvl5pPr marL="3072201" indent="0">
              <a:buNone/>
              <a:defRPr sz="1680"/>
            </a:lvl5pPr>
            <a:lvl6pPr marL="3840251" indent="0">
              <a:buNone/>
              <a:defRPr sz="1680"/>
            </a:lvl6pPr>
            <a:lvl7pPr marL="4608302" indent="0">
              <a:buNone/>
              <a:defRPr sz="1680"/>
            </a:lvl7pPr>
            <a:lvl8pPr marL="5376352" indent="0">
              <a:buNone/>
              <a:defRPr sz="1680"/>
            </a:lvl8pPr>
            <a:lvl9pPr marL="6144402" indent="0">
              <a:buNone/>
              <a:defRPr sz="168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307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768032"/>
            <a:ext cx="5573230" cy="268811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346224" y="1658740"/>
            <a:ext cx="8747969" cy="8187013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050" indent="0">
              <a:buNone/>
              <a:defRPr sz="4704"/>
            </a:lvl2pPr>
            <a:lvl3pPr marL="1536101" indent="0">
              <a:buNone/>
              <a:defRPr sz="4032"/>
            </a:lvl3pPr>
            <a:lvl4pPr marL="2304151" indent="0">
              <a:buNone/>
              <a:defRPr sz="3360"/>
            </a:lvl4pPr>
            <a:lvl5pPr marL="3072201" indent="0">
              <a:buNone/>
              <a:defRPr sz="3360"/>
            </a:lvl5pPr>
            <a:lvl6pPr marL="3840251" indent="0">
              <a:buNone/>
              <a:defRPr sz="3360"/>
            </a:lvl6pPr>
            <a:lvl7pPr marL="4608302" indent="0">
              <a:buNone/>
              <a:defRPr sz="3360"/>
            </a:lvl7pPr>
            <a:lvl8pPr marL="5376352" indent="0">
              <a:buNone/>
              <a:defRPr sz="3360"/>
            </a:lvl8pPr>
            <a:lvl9pPr marL="6144402" indent="0">
              <a:buNone/>
              <a:defRPr sz="336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6" y="3456146"/>
            <a:ext cx="5573230" cy="6402939"/>
          </a:xfrm>
        </p:spPr>
        <p:txBody>
          <a:bodyPr/>
          <a:lstStyle>
            <a:lvl1pPr marL="0" indent="0">
              <a:buNone/>
              <a:defRPr sz="2688"/>
            </a:lvl1pPr>
            <a:lvl2pPr marL="768050" indent="0">
              <a:buNone/>
              <a:defRPr sz="2352"/>
            </a:lvl2pPr>
            <a:lvl3pPr marL="1536101" indent="0">
              <a:buNone/>
              <a:defRPr sz="2016"/>
            </a:lvl3pPr>
            <a:lvl4pPr marL="2304151" indent="0">
              <a:buNone/>
              <a:defRPr sz="1680"/>
            </a:lvl4pPr>
            <a:lvl5pPr marL="3072201" indent="0">
              <a:buNone/>
              <a:defRPr sz="1680"/>
            </a:lvl5pPr>
            <a:lvl6pPr marL="3840251" indent="0">
              <a:buNone/>
              <a:defRPr sz="1680"/>
            </a:lvl6pPr>
            <a:lvl7pPr marL="4608302" indent="0">
              <a:buNone/>
              <a:defRPr sz="1680"/>
            </a:lvl7pPr>
            <a:lvl8pPr marL="5376352" indent="0">
              <a:buNone/>
              <a:defRPr sz="1680"/>
            </a:lvl8pPr>
            <a:lvl9pPr marL="6144402" indent="0">
              <a:buNone/>
              <a:defRPr sz="168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5240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87996" y="613362"/>
            <a:ext cx="14903947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7996" y="3066796"/>
            <a:ext cx="14903947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87996" y="10677788"/>
            <a:ext cx="38879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FA315-A5E8-4120-BB8E-1DB0482A47B5}" type="datetimeFigureOut">
              <a:rPr lang="ko-KR" altLang="en-US" smtClean="0"/>
              <a:t>2016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723980" y="10677788"/>
            <a:ext cx="5831979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203956" y="10677788"/>
            <a:ext cx="38879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D27BE-A99D-4BB2-9150-AD3ECD4BC6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458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101" rtl="0" eaLnBrk="1" latinLnBrk="1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25" indent="-384025" algn="l" defTabSz="1536101" rtl="0" eaLnBrk="1" latinLnBrk="1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075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12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17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226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27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32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037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8427" indent="-384025" algn="l" defTabSz="1536101" rtl="0" eaLnBrk="1" latinLnBrk="1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050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10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15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20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251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30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35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4402" algn="l" defTabSz="1536101" rtl="0" eaLnBrk="1" latinLnBrk="1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324272" y="6275295"/>
            <a:ext cx="10903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.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7994541"/>
              </p:ext>
            </p:extLst>
          </p:nvPr>
        </p:nvGraphicFramePr>
        <p:xfrm>
          <a:off x="2492188" y="3544701"/>
          <a:ext cx="12676093" cy="3913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139888" y="7948055"/>
            <a:ext cx="13207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Differentially expressed ROS/defense-related genes in SSF and </a:t>
            </a:r>
            <a:r>
              <a:rPr lang="en-US" altLang="ko-KR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 values (log2 SSF/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anscripts with significant variations (log2 SSF/</a:t>
            </a:r>
            <a:r>
              <a:rPr lang="en-US" altLang="ko-KR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F</a:t>
            </a:r>
            <a:r>
              <a:rPr lang="en-US" altLang="ko-K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 greater than 1) are shown.</a:t>
            </a:r>
            <a:endParaRPr lang="ko-KR" altLang="ko-K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5383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48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MIN PARK</dc:creator>
  <cp:lastModifiedBy>HYEMIN PARK</cp:lastModifiedBy>
  <cp:revision>5</cp:revision>
  <dcterms:created xsi:type="dcterms:W3CDTF">2016-01-08T09:02:14Z</dcterms:created>
  <dcterms:modified xsi:type="dcterms:W3CDTF">2016-01-29T06:48:32Z</dcterms:modified>
</cp:coreProperties>
</file>